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510" y="9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13A1239-7723-4FD5-84FB-ADE3E5C6F7DB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C48F88-C700-4445-9EB6-5265CAD8A063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FC7D6E-239E-4BB5-9723-D29AF71F3757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B6AB8C-00F0-4B28-8249-C10C0EEE5333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39DBD7-3EA0-4DD6-8C50-8A0E264FBD69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99288D-3AEC-4BB0-AE5F-D802B5068711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47AD3FA-7050-495B-8999-6515469F0113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3BEA36-8BEE-4EA2-B09A-AD7417E6B748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9960F7-8BE6-4E86-B1AC-B3E318AEE309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1C321B-E8F4-414B-9425-88482C686415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52B7B88-C1C0-406B-8DE8-6ECDCFF6FB32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 style du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06F4006C-59D4-4DAF-9E13-1F5F475E7DD8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 Box 6"/>
          <p:cNvSpPr txBox="1">
            <a:spLocks noChangeArrowheads="1"/>
          </p:cNvSpPr>
          <p:nvPr/>
        </p:nvSpPr>
        <p:spPr bwMode="auto">
          <a:xfrm>
            <a:off x="0" y="5516563"/>
            <a:ext cx="9144000" cy="1069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b="1" dirty="0" smtClean="0"/>
              <a:t>Figure </a:t>
            </a:r>
            <a:r>
              <a:rPr lang="en-US" sz="1600" b="1" dirty="0"/>
              <a:t>S1:</a:t>
            </a:r>
            <a:r>
              <a:rPr lang="en-US" sz="1600" dirty="0"/>
              <a:t> QPCR data of 10 selected targets obtained from the cluster analysis. Gene expression was performed respect to 16°C and was normalized against </a:t>
            </a:r>
            <a:r>
              <a:rPr lang="en-US" sz="1600" dirty="0" err="1"/>
              <a:t>Actin</a:t>
            </a:r>
            <a:r>
              <a:rPr lang="en-US" sz="1600" dirty="0"/>
              <a:t>, 18S and </a:t>
            </a:r>
            <a:r>
              <a:rPr lang="en-US" sz="1600" dirty="0" err="1"/>
              <a:t>Ribo</a:t>
            </a:r>
            <a:r>
              <a:rPr lang="en-US" sz="1600" dirty="0"/>
              <a:t> L27. </a:t>
            </a:r>
            <a:r>
              <a:rPr lang="en-GB" sz="1600" dirty="0"/>
              <a:t>* Significantly different from reference condition (16°C), *p&lt; 005 threshold cycle random reallocation test according to [31], n=4. </a:t>
            </a:r>
            <a:r>
              <a:rPr lang="en-US" sz="1600" dirty="0"/>
              <a:t>(Additional information to Table 2, Fig. 4, Fig 5 and Fig 6)</a:t>
            </a:r>
          </a:p>
        </p:txBody>
      </p:sp>
      <p:pic>
        <p:nvPicPr>
          <p:cNvPr id="2051" name="Picture 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0"/>
            <a:ext cx="9144000" cy="55006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Modèle par défaut">
  <a:themeElements>
    <a:clrScheme name="Modèle par défaut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Modèle par défaut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Modèle par défau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75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Modèle par défaut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aaa</dc:creator>
  <cp:lastModifiedBy>Med</cp:lastModifiedBy>
  <cp:revision>5</cp:revision>
  <dcterms:created xsi:type="dcterms:W3CDTF">2010-07-31T09:10:32Z</dcterms:created>
  <dcterms:modified xsi:type="dcterms:W3CDTF">2013-05-19T16:49:05Z</dcterms:modified>
</cp:coreProperties>
</file>